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662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B2C65-C6DA-45EA-867E-2B6106377BC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427F2-BAE8-44F7-B002-41FCAECD76B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818" name="Group 2"/>
          <p:cNvGraphicFramePr>
            <a:graphicFrameLocks noGrp="1"/>
          </p:cNvGraphicFramePr>
          <p:nvPr/>
        </p:nvGraphicFramePr>
        <p:xfrm>
          <a:off x="260351" y="927101"/>
          <a:ext cx="6364288" cy="1950720"/>
        </p:xfrm>
        <a:graphic>
          <a:graphicData uri="http://schemas.openxmlformats.org/drawingml/2006/table">
            <a:tbl>
              <a:tblPr/>
              <a:tblGrid>
                <a:gridCol w="833438"/>
                <a:gridCol w="80962"/>
                <a:gridCol w="725488"/>
                <a:gridCol w="871537"/>
                <a:gridCol w="827088"/>
                <a:gridCol w="835025"/>
                <a:gridCol w="693737"/>
                <a:gridCol w="722313"/>
                <a:gridCol w="774700"/>
              </a:tblGrid>
              <a:tr h="24384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H. sapien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norvegic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M. mus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O. cuni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B. taur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 </a:t>
                      </a: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laevi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 </a:t>
                      </a: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. dolloi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. sapien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9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8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04800" algn="l"/>
                        </a:tabLst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7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8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norvegic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2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6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4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. mus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400" b="0" i="0" u="none" strike="noStrike" cap="none" normalizeH="0" baseline="3000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9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0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. cuni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8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3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. taur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laevi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. dolloi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zh-TW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34985" name="Group 169"/>
          <p:cNvGraphicFramePr>
            <a:graphicFrameLocks noGrp="1"/>
          </p:cNvGraphicFramePr>
          <p:nvPr/>
        </p:nvGraphicFramePr>
        <p:xfrm>
          <a:off x="260350" y="3729039"/>
          <a:ext cx="6337300" cy="2520953"/>
        </p:xfrm>
        <a:graphic>
          <a:graphicData uri="http://schemas.openxmlformats.org/drawingml/2006/table">
            <a:tbl>
              <a:tblPr/>
              <a:tblGrid>
                <a:gridCol w="849313"/>
                <a:gridCol w="74612"/>
                <a:gridCol w="782638"/>
                <a:gridCol w="817562"/>
                <a:gridCol w="815975"/>
                <a:gridCol w="26988"/>
                <a:gridCol w="801687"/>
                <a:gridCol w="687388"/>
                <a:gridCol w="712787"/>
                <a:gridCol w="768350"/>
              </a:tblGrid>
              <a:tr h="258764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H. sapiens</a:t>
                      </a:r>
                      <a:endParaRPr kumimoji="0" lang="en-US" altLang="zh-TW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norvegic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M. mus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O. cuni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B. taur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 </a:t>
                      </a: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laevi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  </a:t>
                      </a: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. dolloi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. sapien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2.8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0.7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04800" algn="l"/>
                        </a:tabLst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4.9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6.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3.8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2.6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norvegic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0.7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2.2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4.4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6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. mus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0.2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2.2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1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. cunicul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5.2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3.9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3.1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. tauru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5.8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8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laevis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9.0</a:t>
                      </a:r>
                      <a:endParaRPr kumimoji="0" lang="en-GB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6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. dolloi</a:t>
                      </a:r>
                      <a:endParaRPr kumimoji="0" lang="en-US" altLang="zh-TW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2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283" name="Text Box 4"/>
          <p:cNvSpPr txBox="1">
            <a:spLocks noChangeArrowheads="1"/>
          </p:cNvSpPr>
          <p:nvPr/>
        </p:nvSpPr>
        <p:spPr bwMode="auto">
          <a:xfrm>
            <a:off x="0" y="666750"/>
            <a:ext cx="2984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200" b="1">
                <a:ea typeface="新細明體" pitchFamily="18" charset="-120"/>
              </a:rPr>
              <a:t>A</a:t>
            </a:r>
          </a:p>
        </p:txBody>
      </p:sp>
      <p:sp>
        <p:nvSpPr>
          <p:cNvPr id="6284" name="Text Box 4"/>
          <p:cNvSpPr txBox="1">
            <a:spLocks noChangeArrowheads="1"/>
          </p:cNvSpPr>
          <p:nvPr/>
        </p:nvSpPr>
        <p:spPr bwMode="auto">
          <a:xfrm>
            <a:off x="0" y="3452815"/>
            <a:ext cx="2984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200" b="1">
                <a:ea typeface="新細明體" pitchFamily="18" charset="-120"/>
              </a:rPr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56</Words>
  <Application>Microsoft Office PowerPoint</Application>
  <PresentationFormat>A4 Paper (210x297 mm)</PresentationFormat>
  <Paragraphs>8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2</cp:revision>
  <dcterms:created xsi:type="dcterms:W3CDTF">2011-04-07T14:05:28Z</dcterms:created>
  <dcterms:modified xsi:type="dcterms:W3CDTF">2011-04-07T14:16:22Z</dcterms:modified>
</cp:coreProperties>
</file>